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2899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2019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6173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47190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6701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103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0466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1855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1991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4157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4667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EF6F1C-2E3A-4DAE-A666-A5C4B84C0871}" type="datetimeFigureOut">
              <a:rPr lang="es-ES" smtClean="0"/>
              <a:t>07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812B6-F6A7-4D7A-9875-C36C12EDDA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5799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3036497" y="5295016"/>
            <a:ext cx="656017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plo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ATPCA using </a:t>
            </a:r>
            <a:r>
              <a:rPr lang="en-US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200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chlockonee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'</a:t>
            </a:r>
            <a:r>
              <a:rPr lang="en-US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berry results of gene expression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TH23, PL8, PG, PME3, EXP4, GH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mechanical propertie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Breakin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lopeS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placementS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BWork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total decay, water los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Los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maturation index (MI) as variables. The component loadings of the variables are represented by black lines, and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 are depicted by blue dots: [(1) freshly harvested; (2) 3 d Air, (3) 3 d 15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4) 3 d 20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5) 14 d Air, (6) 3 d 15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11 d Air, (7) 3 d 20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11 d Air, (8) 29 d Air, (9) 3 d 15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26 d Air, (10) 3 d 20% CO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26 d Air]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3171" y="917709"/>
            <a:ext cx="4950381" cy="43773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90957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2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TERESA SANCHEZ BALLESTA</dc:creator>
  <cp:lastModifiedBy>MARIA TERESA SANCHEZ BALLESTA</cp:lastModifiedBy>
  <cp:revision>2</cp:revision>
  <dcterms:created xsi:type="dcterms:W3CDTF">2024-10-21T09:17:04Z</dcterms:created>
  <dcterms:modified xsi:type="dcterms:W3CDTF">2024-11-07T12:45:27Z</dcterms:modified>
</cp:coreProperties>
</file>